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58D750-5AC0-4895-AFC9-EE59CFBA128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E239A8-A59F-5BCA-05C3-9DF1598892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81B7CD-FB54-8EC9-357E-F73E374CA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9BABD0-840F-AE64-DE72-3E4457FEF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05F9BF-24E2-1086-D5B1-2C39FDCA6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8718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4FD7FA-8D43-038D-8CA6-5DCB5BB807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F77A33-3F89-DA02-1B49-AADD4D43D2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A907CB-F403-3323-C102-6B0C1FA42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422D4B-0971-2DA4-8C57-D68F55538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8134D1-C5AE-1702-7C18-297127FEC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48665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B0828E-31BB-6DF9-5755-2E3B63BCFD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95638F-3A2A-A653-96BF-407138F140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74EC40-84A7-3BA7-BD50-6C4F5F459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FA89CF-D510-66EB-B97F-71A9EDFAA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3A2F4E-9496-A5AA-7466-3C677EBF7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87470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D54AF-9D29-097C-3E3E-1041C6A41D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484C37-AD77-59C9-D965-E685226C5E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449328-843C-2CAF-DE44-39A69921A5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24B08-6F94-5466-E862-39A270109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6C3B83-937F-F71A-A22E-9CD0863DDC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02990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852A44-D7E9-569D-A28A-CBC4D7A1CD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6102DF-EBD5-523B-4C5D-EB31E2F482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9C634B-EC58-C8F7-16FC-CA652094F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B57295-43CE-D0A8-D8E8-485FB60FB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29CDEB-B926-9EE3-2736-1733405F9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79335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D56B25-80C0-CD71-B896-66DA525D89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EC3779-93DB-128A-C28A-130026199A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581D10-FC5B-E621-CCA7-535F795BF0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675CF8-41AC-1C07-112C-70040EEE6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0AB4E1-5FC4-1738-3987-6B0BE9E33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64596B-70AC-06CB-7EDF-EEF9601B6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775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9371EE-0390-6DFE-FF7D-E458242A1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264513-78F0-BF15-B487-E22C4A6882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32A6EE-389F-3277-38A9-1BC9C958EA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DA3675-39DD-63EE-F6F3-F015AA4582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806A690-EF39-06AC-0BB0-75E65860EA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64C5D7-DD8F-1269-F256-349BD11906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CAC315-F392-3B10-541F-9FEEA3378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010902-B8E3-6C19-5FA0-5C69324C4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7386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9E7312-91D4-1299-355C-6ABA8F5ED1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7F9D25-0C65-8A88-9659-C72DB85F5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25070E-32D6-2301-66E7-BD5230DBC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5C91D9-E5BD-7CC0-7E9F-84C9F4F4D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79685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3F510BC-9601-D778-E8DD-0EE9EB79F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F406D1-F12A-154F-6A36-2BE61151F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EB9282F-DE81-445C-CFA2-151DF76FB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1351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84EA4D-8084-69B7-377C-E42DC58DFB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0EA934-8029-A56F-3B02-9284A5FCD8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A2794B-E621-17EA-FD33-7017B5C943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7700DA-FC73-C8D8-BA3E-310F28B6F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98F1A0-D2E9-B524-2D57-29D645CAF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FC93FD-7AE6-A126-09EC-12A601F0B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9628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4CBE6F-71E0-A6B0-BF50-39D0CE4E4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B6434F-39EF-AF08-5874-37BF9D5B15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7F1930-9853-9FA4-2A08-EF48811B76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6E62E7-F448-65FC-B532-744F0CBB6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D88A89-CED2-3309-58CC-2C5451539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C4A5EA-CECF-808B-DEF3-FFD692D8C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33317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6E5E21-8C24-A613-53D5-A0215BF49D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39A892-F118-DF23-74CD-F0DC1325AC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23CF10-1426-7052-8E5A-581855A8A7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997376-AB24-4CF9-B76E-1065735E34BB}" type="datetimeFigureOut">
              <a:rPr lang="en-IN" smtClean="0"/>
              <a:t>15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6EC62C-A8A6-F6D4-1341-9F36271A18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5F56D4-3955-4FA2-BBA7-650AA8FC0A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CD6403-468F-4CDB-9564-BF7C8DD2F0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6769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2EB64CF1-A9F2-B030-E668-A2EFFDDC89A0}"/>
              </a:ext>
            </a:extLst>
          </p:cNvPr>
          <p:cNvGrpSpPr/>
          <p:nvPr/>
        </p:nvGrpSpPr>
        <p:grpSpPr>
          <a:xfrm>
            <a:off x="2820185" y="313971"/>
            <a:ext cx="6551629" cy="5429839"/>
            <a:chOff x="2846895" y="622170"/>
            <a:chExt cx="6551629" cy="5429839"/>
          </a:xfrm>
        </p:grpSpPr>
        <p:pic>
          <p:nvPicPr>
            <p:cNvPr id="3" name="Picture 2" descr="A green and yellow flowers on a black background&#10;&#10;Description automatically generated">
              <a:extLst>
                <a:ext uri="{FF2B5EF4-FFF2-40B4-BE49-F238E27FC236}">
                  <a16:creationId xmlns:a16="http://schemas.microsoft.com/office/drawing/2014/main" id="{A48C5958-F3C3-E333-E8C3-321F3210EA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5" t="3073" r="59949" b="2992"/>
            <a:stretch/>
          </p:blipFill>
          <p:spPr>
            <a:xfrm>
              <a:off x="2846895" y="622170"/>
              <a:ext cx="4656842" cy="5429839"/>
            </a:xfrm>
            <a:prstGeom prst="rect">
              <a:avLst/>
            </a:prstGeom>
          </p:spPr>
        </p:pic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1A7182AD-EAF9-40E9-2DB1-23B0D3960DF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6090" y="2045617"/>
              <a:ext cx="565607" cy="56560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3ABD7FC2-4976-C242-32E7-9D190F7407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6089" y="2733774"/>
              <a:ext cx="56560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693BC46-9D87-1869-8B6D-144316BC8E48}"/>
                </a:ext>
              </a:extLst>
            </p:cNvPr>
            <p:cNvSpPr txBox="1"/>
            <p:nvPr/>
          </p:nvSpPr>
          <p:spPr>
            <a:xfrm>
              <a:off x="7701697" y="1857081"/>
              <a:ext cx="157427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cked </a:t>
              </a:r>
            </a:p>
            <a:p>
              <a:r>
                <a:rPr lang="en-US" dirty="0" err="1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ichostatin</a:t>
              </a:r>
              <a:r>
                <a:rPr lang="en-US" dirty="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</a:t>
              </a:r>
              <a:endParaRPr lang="en-IN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659DE48-158E-DD11-0D60-2E71A357312C}"/>
                </a:ext>
              </a:extLst>
            </p:cNvPr>
            <p:cNvSpPr txBox="1"/>
            <p:nvPr/>
          </p:nvSpPr>
          <p:spPr>
            <a:xfrm>
              <a:off x="7701697" y="2594057"/>
              <a:ext cx="169682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-crystalized </a:t>
              </a:r>
              <a:r>
                <a:rPr lang="en-US" dirty="0" err="1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ichostatin</a:t>
              </a:r>
              <a:r>
                <a:rPr lang="en-US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</a:t>
              </a:r>
              <a:endParaRPr lang="en-IN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B36217F-ACDF-9157-DBEC-A6A25AA08646}"/>
                </a:ext>
              </a:extLst>
            </p:cNvPr>
            <p:cNvSpPr txBox="1"/>
            <p:nvPr/>
          </p:nvSpPr>
          <p:spPr>
            <a:xfrm>
              <a:off x="6631754" y="826310"/>
              <a:ext cx="10699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DAC6</a:t>
              </a:r>
              <a:endParaRPr lang="en-IN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Rectangle 15">
            <a:extLst>
              <a:ext uri="{FF2B5EF4-FFF2-40B4-BE49-F238E27FC236}">
                <a16:creationId xmlns:a16="http://schemas.microsoft.com/office/drawing/2014/main" id="{E9F74D5A-9C02-6CC1-F8FD-D4BEBB7F7346}"/>
              </a:ext>
            </a:extLst>
          </p:cNvPr>
          <p:cNvSpPr/>
          <p:nvPr/>
        </p:nvSpPr>
        <p:spPr>
          <a:xfrm>
            <a:off x="212100" y="6143919"/>
            <a:ext cx="1181650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IN" sz="2000" b="1" dirty="0">
              <a:solidFill>
                <a:srgbClr val="00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DAC9537-FF35-88C5-41ED-BFED82685A57}"/>
              </a:ext>
            </a:extLst>
          </p:cNvPr>
          <p:cNvSpPr txBox="1"/>
          <p:nvPr/>
        </p:nvSpPr>
        <p:spPr>
          <a:xfrm>
            <a:off x="212100" y="6047501"/>
            <a:ext cx="119799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: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The docked conformation of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Trichostatin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A with HDAC6 superimposed with its co-crystallized position. The figure was generated using PyMOL, based on the Protein Data Bank coordinates (PDB ID: 5EDU).</a:t>
            </a:r>
            <a:endParaRPr lang="en-I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7529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4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3</cp:revision>
  <dcterms:created xsi:type="dcterms:W3CDTF">2024-10-11T14:23:38Z</dcterms:created>
  <dcterms:modified xsi:type="dcterms:W3CDTF">2024-10-15T11:43:18Z</dcterms:modified>
</cp:coreProperties>
</file>